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8EBD223-2A75-FBE9-C41E-58DDC2508E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BB859930-D79D-10CF-4F8B-71ECED3857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886E5B-E81F-ECAF-3993-0B5A8EEF1B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C690ED8-110A-77B7-064B-2EB8D9CB7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ADEAC04-69A5-CA38-E794-B4481F7A0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589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6AB1DCC-0744-09A5-889A-B0300C848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7299DDB-526E-1D73-9EAA-60C393FA61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9D12C1-B902-8EC1-B705-F5500D1BB5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0BAA76A-8F74-FB9C-CECD-8345A2CBC3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BECE77-33A1-108E-B6ED-7B71F6E91E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006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813EED3-BE7C-90FF-4776-99CEFB898E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46D488-2D79-C5AB-1DF2-6DBBDFB8A0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79573C2-1E06-DCE2-5B54-560395F8B3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554475-2387-1437-3981-DD156E5D2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6DFE5F-DBDB-E13F-7C1A-179B6AC33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38892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5A5D1A-33B0-F0DA-2CA3-36ADB3D3F1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974AFF5-4109-4F5A-3FA5-B9923480D1C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0428000-56BE-961E-2176-5CAF861EB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3148686-FC3E-DA41-84AF-0511C6A49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27ED3D-D148-9084-EE9E-681364124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9598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5115AE-6250-985A-A5D4-22D3AF97F4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A95F284-B727-B7D7-D787-2373A7AF3D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45A70EE-5DFD-A33D-4BF1-A33440928A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E4F6A0-9E7C-2A96-01A2-1D381C237D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E196AC-EAB3-9B41-B0E4-F5EEE428AE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31299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95E2FF-8AE6-7F9D-3446-B1C3224E28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FF38C92-42F4-23EB-959D-0D1A53581F8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FAE650D-090E-A842-D68D-1C9F885884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D6BB4BF-6BC3-A85B-98C3-F3FF2F9AD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E756665-0069-BDE4-9E3E-008745937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42EE238-983B-5D8B-A80B-D94F8A9251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17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05865B8-0979-C26A-A018-E4967E511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DA4732-8479-1231-1817-BCA0512802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F0C5422-C4C9-49D7-314D-88C8595F35A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5F8A1E29-1408-9EAE-42B8-9277422DCE4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0E097CE-24F8-363A-A57A-488291C471A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0DEE402-D163-D742-10EF-111C96B857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EF0CC7CE-10D5-04DE-149A-151CFFA82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2385F61-4A70-7A8C-184F-9F0AB1BAB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1033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32FE90-5626-7569-B20B-FE4F1E8B10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6D622ED-E1AF-0777-3B47-E4A8378A3F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84C5DE8B-6D38-3534-F88B-88E4543D6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33C40B25-AD15-1E76-D316-764F226E9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4208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CD33A18-1D0F-558C-AF4B-B786A8D39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E7E4AC0-0396-4BC5-5A99-A126273C56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69C6A3F7-2702-9281-F336-6613F86F9F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73484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A46B579-42E1-1C9C-D28D-87F14136B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A7BD819-226C-ABCB-FB0D-0FD177509A5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345199F-D92C-D657-C372-48FE276794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EB0A89D-3402-1387-6FDD-C1B464976C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1071B9-C3E1-5742-56EA-D22CA0D88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8B89D67-D8D9-D32B-F5E3-E830FC949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9157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FABDFB-C710-8331-033E-397847949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DF402FE-61C1-F847-8F26-E264B53F50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921D364-E9D4-AB32-D440-147635BB11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0B9518-F712-9D7E-906C-D01E4299E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B57195-E2E6-3F78-9B8F-5BA0F5924F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F062E5ED-75E4-7FA2-1B5C-FCABAC8D27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86782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FB936CE0-8A5F-B7C4-F64E-7A68CDD53F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7E0A5FA-6ED2-1C6C-EAB8-8C14D86D84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942271-FEF2-8110-68FC-CD81FDD5E1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A8117-29B0-EF47-827A-E4F43F2EEFD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F478657-8836-3F3B-F397-2843C579C77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2FA5CD5-783C-F69A-E4F0-034DF4978D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12109-8422-1E4D-BEC0-086059055A3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3626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>
            <a:extLst>
              <a:ext uri="{FF2B5EF4-FFF2-40B4-BE49-F238E27FC236}">
                <a16:creationId xmlns:a16="http://schemas.microsoft.com/office/drawing/2014/main" id="{202CBAF8-76DB-7E69-6C03-ACB06E6ACF9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45779" b="10195"/>
          <a:stretch/>
        </p:blipFill>
        <p:spPr>
          <a:xfrm>
            <a:off x="3731171" y="348344"/>
            <a:ext cx="4683485" cy="4609266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2E2E237D-46AA-037D-78AC-1020AA544AC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90041"/>
          <a:stretch/>
        </p:blipFill>
        <p:spPr>
          <a:xfrm>
            <a:off x="1188076" y="4957610"/>
            <a:ext cx="10301777" cy="609600"/>
          </a:xfrm>
          <a:prstGeom prst="rect">
            <a:avLst/>
          </a:prstGeom>
        </p:spPr>
      </p:pic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EEE063E8-98C5-DFF1-6B7F-73F1643F925B}"/>
              </a:ext>
            </a:extLst>
          </p:cNvPr>
          <p:cNvSpPr/>
          <p:nvPr/>
        </p:nvSpPr>
        <p:spPr>
          <a:xfrm>
            <a:off x="3849485" y="-20989"/>
            <a:ext cx="42915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i="1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TERTp</a:t>
            </a:r>
            <a:r>
              <a:rPr lang="en-US" altLang="ja-JP" dirty="0">
                <a:latin typeface="Times New Roman" panose="02020603050405020304" pitchFamily="18" charset="0"/>
                <a:ea typeface="游明朝" panose="02020400000000000000" pitchFamily="18" charset="-128"/>
              </a:rPr>
              <a:t> wildtype GBM in our cohort (n=65)</a:t>
            </a:r>
            <a:r>
              <a:rPr lang="ja-JP" altLang="ja-JP">
                <a:effectLst/>
              </a:rPr>
              <a:t> </a:t>
            </a:r>
            <a:endParaRPr lang="ja-JP" altLang="en-US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45FF8D13-EFD6-4012-68EE-1ABAD9CA5E6F}"/>
              </a:ext>
            </a:extLst>
          </p:cNvPr>
          <p:cNvSpPr txBox="1"/>
          <p:nvPr/>
        </p:nvSpPr>
        <p:spPr>
          <a:xfrm>
            <a:off x="2293300" y="5804783"/>
            <a:ext cx="9196553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matic alterations of driver genes in </a:t>
            </a:r>
            <a:r>
              <a:rPr lang="en-US" altLang="ja-JP" sz="16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DH-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altLang="ja-JP" sz="16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ERTp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wildtype glioblastomas. Driver gene mutations and copy number alterations were generated and visualized using </a:t>
            </a:r>
            <a:r>
              <a:rPr lang="en-US" altLang="ja-JP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ncoPrinter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cluded in the </a:t>
            </a:r>
            <a:r>
              <a:rPr lang="en-US" altLang="ja-JP" sz="16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BioPortal</a:t>
            </a:r>
            <a:r>
              <a:rPr lang="en-US" altLang="ja-JP" sz="16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or Cancer Genomics software suite. GBM, glioblastoma</a:t>
            </a:r>
            <a:endParaRPr lang="ja-JP" altLang="ja-JP" sz="1600" kern="10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682324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1</Words>
  <Application>Microsoft Macintosh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比嘉　那優大</dc:creator>
  <cp:lastModifiedBy>那優大 比嘉</cp:lastModifiedBy>
  <cp:revision>3</cp:revision>
  <dcterms:created xsi:type="dcterms:W3CDTF">2023-01-18T11:48:21Z</dcterms:created>
  <dcterms:modified xsi:type="dcterms:W3CDTF">2023-03-21T05:03:54Z</dcterms:modified>
</cp:coreProperties>
</file>